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5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35503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31032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785377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81068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133140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310021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11932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0378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03543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00736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898570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F83FF1-95F9-4BBD-9E29-357F60675C27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2D5ABF-01F0-4BE6-81AF-557AE19EE24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31618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95784" y="265710"/>
            <a:ext cx="10028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in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inicopathology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tween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 and negative EOGC patient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543532503"/>
              </p:ext>
            </p:extLst>
          </p:nvPr>
        </p:nvGraphicFramePr>
        <p:xfrm>
          <a:off x="395784" y="1060282"/>
          <a:ext cx="11447327" cy="5206835"/>
        </p:xfrm>
        <a:graphic>
          <a:graphicData uri="http://schemas.openxmlformats.org/drawingml/2006/table">
            <a:tbl>
              <a:tblPr firstRow="1" firstCol="1" bandRow="1"/>
              <a:tblGrid>
                <a:gridCol w="845713"/>
                <a:gridCol w="1477437"/>
                <a:gridCol w="909815"/>
                <a:gridCol w="979800"/>
                <a:gridCol w="1036513"/>
                <a:gridCol w="670083"/>
                <a:gridCol w="742906"/>
                <a:gridCol w="447337"/>
                <a:gridCol w="850663"/>
                <a:gridCol w="858233"/>
                <a:gridCol w="1015556"/>
                <a:gridCol w="1058025"/>
                <a:gridCol w="555246"/>
              </a:tblGrid>
              <a:tr h="677814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linicopathologic</a:t>
                      </a:r>
                      <a:r>
                        <a:rPr lang="en-US" sz="1200" b="1" kern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kern="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haracteristics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otal Number (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=13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i="1" kern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p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positive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n=7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%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i="1" kern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p</a:t>
                      </a: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negative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n=67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%)</a:t>
                      </a:r>
                      <a:endParaRPr lang="zh-CN" alt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153035" algn="ctr">
                        <a:spcAft>
                          <a:spcPts val="0"/>
                        </a:spcAft>
                      </a:pPr>
                      <a:r>
                        <a:rPr lang="en-US" sz="1200" b="1" i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200" i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linicopathologic</a:t>
                      </a: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haracteristics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otal Number (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=13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i="1" kern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p</a:t>
                      </a: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ositive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n=7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%)</a:t>
                      </a:r>
                      <a:endParaRPr lang="zh-CN" alt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i="1" kern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p</a:t>
                      </a: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negative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n=67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%)</a:t>
                      </a:r>
                      <a:endParaRPr lang="zh-CN" alt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153035" algn="ctr">
                        <a:spcAft>
                          <a:spcPts val="0"/>
                        </a:spcAft>
                      </a:pPr>
                      <a:r>
                        <a:rPr lang="en-US" sz="1200" b="1" i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ender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al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9(35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5 (35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4 (35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99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just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linical Staging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2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002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emal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8(64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 (</a:t>
                      </a: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4.3</a:t>
                      </a: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 (64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zh-CN" alt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304800"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A+IB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8(27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9(41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9(13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ale/Female ratio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6/1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6/1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6/1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IA+IIB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(20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(15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(25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ge</a:t>
                      </a: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3.9±5.29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0±5.08</a:t>
                      </a:r>
                      <a:endParaRPr lang="zh-CN" altLang="en-US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8±5.33</a:t>
                      </a:r>
                      <a:endParaRPr lang="zh-CN" altLang="en-US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018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II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7(41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6(37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1(46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835">
                <a:tc rowSpan="2" gridSpan="2">
                  <a:txBody>
                    <a:bodyPr/>
                    <a:lstStyle/>
                    <a:p>
                      <a:r>
                        <a:rPr lang="en-US" altLang="zh-CN" sz="1200" b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mily history</a:t>
                      </a:r>
                      <a:endParaRPr lang="zh-CN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(25.5)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(24.3)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(26.9)</a:t>
                      </a:r>
                      <a:endParaRPr lang="zh-CN" altLang="en-US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9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V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4(10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(5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0(14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 gridSpan="2"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VI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74(54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5(50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9(58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335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0697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ration of symptom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 year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15(83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1(72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4(95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001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just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NI</a:t>
                      </a: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3(60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3(47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0(74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001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1 year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2(16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9(27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(4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N metastasis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6(62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0(57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6(68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163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location</a:t>
                      </a: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roxima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(4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(5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(3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336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stasis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4(10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(5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0(14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075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049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Middl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2(38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2(31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0(44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djuvant treatment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06(77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3(75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3(79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35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>
                  <a:txBody>
                    <a:bodyPr/>
                    <a:lstStyle/>
                    <a:p>
                      <a:pPr algn="l"/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Dista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70(51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8(54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2(47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lapse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5(32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0(28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5(37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76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initis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lastica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9(6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(8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(4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3661">
                <a:tc rowSpan="2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1" i="0" u="none" strike="noStrike" kern="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Size (cm)</a:t>
                      </a: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Overal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.4±2.9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.8 ±2.8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.0 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.8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0" i="0" u="none" strike="noStrike" kern="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250</a:t>
                      </a: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ead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6(26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5(21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1(31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88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al Rate</a:t>
                      </a:r>
                      <a:endParaRPr kumimoji="0" lang="zh-CN" altLang="zh-CN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022</a:t>
                      </a:r>
                      <a:endParaRPr lang="zh-CN" altLang="zh-CN" sz="1200" kern="100" baseline="300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8023">
                <a:tc rowSpan="2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Rang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3-15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5-15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3-13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year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4.3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7.4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1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3661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2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2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2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years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73.6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0.4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5.3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13360">
                <a:tc row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auren’s classification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use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(78.7)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(75.0)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(82.5)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6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years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.0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.6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1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2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ntestina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2(9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1(17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(1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87322">
                <a:tc vMerge="1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Mixed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5(11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(7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0(14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all Survival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onth after surgery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3.01±5.05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3.17±6.17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7.11±7.49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2687077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8</Words>
  <Application>Microsoft Office PowerPoint</Application>
  <PresentationFormat>Custom</PresentationFormat>
  <Paragraphs>17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帆</dc:creator>
  <cp:lastModifiedBy>74537</cp:lastModifiedBy>
  <cp:revision>1</cp:revision>
  <dcterms:created xsi:type="dcterms:W3CDTF">2015-11-28T17:51:35Z</dcterms:created>
  <dcterms:modified xsi:type="dcterms:W3CDTF">2016-03-03T19:06:23Z</dcterms:modified>
</cp:coreProperties>
</file>